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772400" cy="105156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107DEC-A46C-49A4-B1BD-42F64B01968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88800" y="420840"/>
            <a:ext cx="6994800" cy="17524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ctr">
            <a:noAutofit/>
          </a:bodyPr>
          <a:p>
            <a:pPr indent="0" algn="ctr">
              <a:buNone/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88800" y="2453760"/>
            <a:ext cx="6994800" cy="330984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88800" y="6078600"/>
            <a:ext cx="6994800" cy="330984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D1B1ED-041A-4E1E-8C1C-92BD80A0455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88800" y="420840"/>
            <a:ext cx="6994800" cy="17524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ctr">
            <a:noAutofit/>
          </a:bodyPr>
          <a:p>
            <a:pPr indent="0" algn="ctr">
              <a:buNone/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88800" y="2453760"/>
            <a:ext cx="3413160" cy="330984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972960" y="2453760"/>
            <a:ext cx="3413160" cy="330984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88800" y="6078600"/>
            <a:ext cx="3413160" cy="330984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972960" y="6078600"/>
            <a:ext cx="3413160" cy="330984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D1844F-DAF8-4484-8964-06692E9B24E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88800" y="420840"/>
            <a:ext cx="6994800" cy="17524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ctr">
            <a:noAutofit/>
          </a:bodyPr>
          <a:p>
            <a:pPr indent="0" algn="ctr">
              <a:buNone/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88800" y="2453760"/>
            <a:ext cx="2252160" cy="330984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754000" y="2453760"/>
            <a:ext cx="2252160" cy="330984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119200" y="2453760"/>
            <a:ext cx="2252160" cy="330984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88800" y="6078600"/>
            <a:ext cx="2252160" cy="330984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754000" y="6078600"/>
            <a:ext cx="2252160" cy="330984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119200" y="6078600"/>
            <a:ext cx="2252160" cy="330984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2A825D-009E-4072-9ECE-A20E992EE63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88800" y="420840"/>
            <a:ext cx="6994800" cy="17524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ctr">
            <a:noAutofit/>
          </a:bodyPr>
          <a:p>
            <a:pPr indent="0" algn="ctr">
              <a:buNone/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88800" y="2453760"/>
            <a:ext cx="6994800" cy="6939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50"/>
              </a:spcBef>
              <a:buNone/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5B2CE9-B6EB-4B32-A938-28995B3DC10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88800" y="420840"/>
            <a:ext cx="6994800" cy="17524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ctr">
            <a:noAutofit/>
          </a:bodyPr>
          <a:p>
            <a:pPr indent="0" algn="ctr">
              <a:buNone/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88800" y="2453760"/>
            <a:ext cx="6994800" cy="693900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C8C2CE-12E6-42FE-A961-147D5EC6704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88800" y="420840"/>
            <a:ext cx="6994800" cy="17524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ctr">
            <a:noAutofit/>
          </a:bodyPr>
          <a:p>
            <a:pPr indent="0" algn="ctr">
              <a:buNone/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88800" y="2453760"/>
            <a:ext cx="3413160" cy="693900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972960" y="2453760"/>
            <a:ext cx="3413160" cy="693900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260DDF-CFBE-42C3-8FA3-500F668CE7B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88800" y="420840"/>
            <a:ext cx="6994800" cy="17524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ctr">
            <a:noAutofit/>
          </a:bodyPr>
          <a:p>
            <a:pPr indent="0" algn="ctr">
              <a:buNone/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F67114-24EF-4C4A-9046-F431F676624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88800" y="420840"/>
            <a:ext cx="6994800" cy="8124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50"/>
              </a:spcBef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9ABB7C-EA32-4EB2-94D6-5F97432CD92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88800" y="420840"/>
            <a:ext cx="6994800" cy="17524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ctr">
            <a:noAutofit/>
          </a:bodyPr>
          <a:p>
            <a:pPr indent="0" algn="ctr">
              <a:buNone/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88800" y="2453760"/>
            <a:ext cx="3413160" cy="330984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972960" y="2453760"/>
            <a:ext cx="3413160" cy="693900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88800" y="6078600"/>
            <a:ext cx="3413160" cy="330984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9092CB-C107-4FB6-8E6E-A2B08E599F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88800" y="420840"/>
            <a:ext cx="6994800" cy="17524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ctr">
            <a:noAutofit/>
          </a:bodyPr>
          <a:p>
            <a:pPr indent="0" algn="ctr">
              <a:buNone/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88800" y="2453760"/>
            <a:ext cx="3413160" cy="693900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972960" y="2453760"/>
            <a:ext cx="3413160" cy="330984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972960" y="6078600"/>
            <a:ext cx="3413160" cy="330984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66469C-AF3C-4E31-8FB5-1EDBAE1442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88800" y="420840"/>
            <a:ext cx="6994800" cy="17524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ctr">
            <a:noAutofit/>
          </a:bodyPr>
          <a:p>
            <a:pPr indent="0" algn="ctr">
              <a:buNone/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88800" y="2453760"/>
            <a:ext cx="3413160" cy="330984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972960" y="2453760"/>
            <a:ext cx="3413160" cy="330984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88800" y="6078600"/>
            <a:ext cx="6994800" cy="330984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FA96D1-321A-43FE-86A1-9186824A91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88800" y="420840"/>
            <a:ext cx="6994800" cy="175248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ctr">
            <a:noAutofit/>
          </a:bodyPr>
          <a:p>
            <a:pPr indent="0" algn="ctr">
              <a:buNone/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46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88800" y="2453760"/>
            <a:ext cx="6994800" cy="693900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rmAutofit/>
          </a:bodyPr>
          <a:p>
            <a:pPr marL="360360" indent="-360360"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1" marL="782640" indent="-299880">
              <a:spcBef>
                <a:spcPts val="850"/>
              </a:spcBef>
              <a:buClr>
                <a:srgbClr val="000000"/>
              </a:buClr>
              <a:buFont typeface="Arial"/>
              <a:buChar char="–"/>
              <a:tabLst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2" marL="1203480" indent="-239760"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3" marL="1685880" indent="-239760">
              <a:spcBef>
                <a:spcPts val="850"/>
              </a:spcBef>
              <a:buClr>
                <a:srgbClr val="000000"/>
              </a:buClr>
              <a:buFont typeface="Arial"/>
              <a:buChar char="–"/>
              <a:tabLst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4" marL="2166840" indent="-239760">
              <a:spcBef>
                <a:spcPts val="850"/>
              </a:spcBef>
              <a:buClr>
                <a:srgbClr val="000000"/>
              </a:buClr>
              <a:buFont typeface="Arial"/>
              <a:buChar char="»"/>
              <a:tabLst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5" marL="2166840" indent="-239760">
              <a:spcBef>
                <a:spcPts val="850"/>
              </a:spcBef>
              <a:buClr>
                <a:srgbClr val="000000"/>
              </a:buClr>
              <a:buFont typeface="Arial"/>
              <a:buChar char="»"/>
              <a:tabLst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6" marL="2166840" indent="-239760">
              <a:spcBef>
                <a:spcPts val="850"/>
              </a:spcBef>
              <a:buClr>
                <a:srgbClr val="000000"/>
              </a:buClr>
              <a:buFont typeface="Arial"/>
              <a:buChar char="»"/>
              <a:tabLst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88800" y="9745200"/>
            <a:ext cx="1812960" cy="56052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  <a:defRPr b="0" lang="en-US" sz="13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fld id="{45B07D95-1D86-4452-9068-FFE64E8BE041}" type="datetime">
              <a:rPr b="0" lang="en-US" sz="13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655720" y="9745200"/>
            <a:ext cx="2460960" cy="56052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ctr">
            <a:noAutofit/>
          </a:bodyPr>
          <a:p>
            <a:pPr indent="0">
              <a:buNone/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570640" y="9745200"/>
            <a:ext cx="1812960" cy="56052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  <a:defRPr b="0" lang="en-US" sz="13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fld id="{FBB4C546-2A07-4580-80EA-D7B0B76B9EE9}" type="slidenum">
              <a:rPr b="0" lang="en-US" sz="13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0"/>
          <p:cNvSpPr/>
          <p:nvPr/>
        </p:nvSpPr>
        <p:spPr>
          <a:xfrm>
            <a:off x="209520" y="19080"/>
            <a:ext cx="7397640" cy="8643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Pig    IPVPQIKPLERHAIDKSVNLNLLAKSKAPVQDELNA</a:t>
            </a:r>
            <a:r>
              <a:rPr b="1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N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DTTKGSGIPMHDHDIGRQQDTKDGYKGER</a:t>
            </a:r>
            <a:r>
              <a:rPr b="0" lang="en-US" sz="1100" spc="-1" strike="noStrike" u="sng">
                <a:solidFill>
                  <a:srgbClr val="000000"/>
                </a:solidFill>
                <a:uFillTx/>
                <a:latin typeface="Courier New"/>
                <a:ea typeface="Courier New"/>
              </a:rPr>
              <a:t>N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GSEWADVGG</a:t>
            </a:r>
            <a:r>
              <a:rPr b="1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N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  77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Panda  --VPQIKPLERHAVDKFANLNLLEKAKVLIQDELNANDTTKESGVP-HENERGRQQYTKDGYKEERNGSEWVEVGRK  7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Dog    SSVPQIKPLDRHAVDKSANLNLPEKVKLPIQDELNASDTTKESGVL-RENERGRQQYTKDGYKEERNGSEWAQIGGK  76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Monkey IPVPQSKPLERH-VEKSMNLHLLARSNVSEQDKLNASGTIKESGVPVHEGDKGRQENTQDGHKREGNGSEWAEVGGK  76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Human  IPVPQSKPLERH-VEKSMNLHLLARSNVSVQDELNASGTIKESGVLVHEGDRGRQENTQDGHKGEGNGSKWAEVGGK  76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Mouse  IPVPQLVPLERDIVENSVAVPLLTHPGTAAQNELSINSTTSNSNDSPDGSEIGEQVLSEDGYKRDGNGSESIHVGGK  77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Rat    IPVPQLVPLERDIVEKSADVPFLAHPGTAAQNELHINNATN--DDSPKGSELGRQVHSNGGYERDRNGSESIAVGGK  7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Conser   ***  **:*. :::   : :  :     *::*  ..: .  .      : *.*  ::.*:: : ***:   :* :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Pig    SSSARPMLANKEENTEDPNGDAGQPEPYGHDGLHGRGDSSPANGLRGQVSILDNTGTA</a:t>
            </a:r>
            <a:r>
              <a:rPr b="1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N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GSHVNGVTDKNSKNE-DV 15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Panda  SSSTHAMLVNDEGNSEDQNGVTGKPETYGYDGIHRKEGSITANGIRGQISIIDNAGIANGSNINRNTDKNLNNGGDV 15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Dog    TS-THSLLVNEEGNSEGQNGVTGKPETYGYDGIDGKEGNITANGIRGQVSITNNAGIANGSNINRNTDENSNKGGNV 15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Monkey SFSTYSTLAYEEGNIEGWNGDIGKAETYDHDGIHGKEENTTANGIQGQVSIIDNAGTTNRSNTDGNTDKNTPNG-DV 15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Human  SFSTYSTLANEEGNIEGWNGDTGKAETYGHDGIHGKEENITANGIQGQVSIIDNAGATNRSNTNGNTDKNTQNG-DV 15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Mouse  DFPTQPILVNEQGNTAE---EHNDIETYGHDGVHARGENSTANGIRSQVGIVENAEEA-ESSVHGQAGQNTKSG-GA 14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Rat    SSPTQPILANAQGNSAK---EREDVETYGHDGIHAGGENSTANGIRGQVGIAENAEEAKESKVHGQPHQDTKTG-LA 148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Conser    : . *.  : *         . *.*.:**:.    . .***::.*:.* :*:  :  *  .  . ::  .   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Pig    G</a:t>
            </a:r>
            <a:r>
              <a:rPr b="1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N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ASQSE</a:t>
            </a:r>
            <a:r>
              <a:rPr b="1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N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ATVVPEDRYQVAGS</a:t>
            </a:r>
            <a:r>
              <a:rPr b="1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N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NSIGHEDEINGNF</a:t>
            </a:r>
            <a:r>
              <a:rPr b="1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C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RNGGDVSET</a:t>
            </a:r>
            <a:r>
              <a:rPr b="1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T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PPGEGEINGNEETGV</a:t>
            </a:r>
            <a:r>
              <a:rPr b="1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T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SGGSGAGNREFAGL 23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Panda  GDASQSENATVVQEVDHQIAESNNSTGHEDEINRNSCRNEGDRSEMTPQRESEGNGNQEAGVTPGGSGAGNGEDAGL 228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Dog    GDASQSEDATVVQEDGHQIAGNNNSTGHEDEINRNYCRNEGDTSEITTQRESEKNANQEAGVTPGESGAGNGEDAGL 227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Monkey GDAGRNEDATVVQEDGPQVAGSNNSTDNEDEIIENSCGNEGNTSEITPQINSNRNGTKEAEVTPS-----TREDAGL 22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Human  GDAGHNEDVAVVQEDGPQVAGSNNSTDNEDEIIENSCRNEGNTSEITPQINSKRNGTKEAEVTPG-----TGEDAGL 22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Mouse  SDVSQNGDATLVQENEPPEASIKNSTNHEAGIHG----SGVATHETTPQREGLGSENQGTEVTPS-----IGEDAGL 217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Rat    SDTSQNGDATLVQENEPQVAGSKNSTNHEVGTHG----SGVAAQETTPQREGEGSENQGAEVTPS-----IGEGAGL 216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Conser .:..:. :.::* *     *  :** .:*         .     * *.  :.  . .: : **..       * ***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Pig    DNSDGSP</a:t>
            </a:r>
            <a:r>
              <a:rPr b="1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S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GNGADEEEDKG</a:t>
            </a:r>
            <a:r>
              <a:rPr b="1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S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GDDEGEETGNGERTADTSKGQEN---PSHGEEEAEEEDDDHSLGQNSISSEDEGPGH 30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Panda  DNSDGSPSGNGADEDEDKGSGDDEGEETGDGKEGTDNSKGQEG---QSHGKD-----DNDNSLGQNSISSEADDPED 297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Dog    DNSDGSPSGNGADEDEDKGSGDDEGEETGNGKEGTDNRKGQEG---QPHGKD-----DNDSSLGQNSISSEDDGPED 296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Monkey DNSDGSPSGNGADEDEDKGSGDDEDEETGNGKDSNDNSKGQEGQDSQDHRKED----DHDSSTGQNSESNEDYDPEG 29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Human  DNSDGSPSGNGADEDEDEGSGDDEDEEAGNGKDSSNNSKGQEG---QDHGKED----DHDSSIGQNSDSKEYYDPEG 29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Mouse  DDTDGSPSGNGVEEDEDTGSGDGEGAEAGDGRESHDGTKGQGG---QSHGGN-------TDHRGQSSVSTEDDDSKE 28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Rat    DNTEGSPSGNGIEEDEDTGSGDGVGADAGDGRESHDGTEGHEG---QSSGGN-------NDNRGQGSVSTEDDDSKE 28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Conser *:::******* :*:** ****. . ::*:*.   :  :*: .        :           **.* *.*  .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Pig    KEAAH-ATDGDN</a:t>
            </a:r>
            <a:r>
              <a:rPr b="1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T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SKSEEDSDNIPGESRSQRIEDTQKPNQRETKAVANGVTAISEPLAIGKSQDKGIEIAAPRSGNR 38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Panda  KEDPH-HIDGDNTSKSEEDSDGVSKDKGSPIVEAIQKPNYRENKAVEKKITDESEPGATGKSQNKGIEMEGPSSGNR 37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Dog    KEDLH-DIGGDNTSKSEEDSDGVPKDKDSPIIEDVQKLNYRENKAVEKKITGESEPVAIGKSQDKGIEMEGPRSGNR 37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Monkey KEDPHNNADGDNTSKSEENSAGILEDNGSQRMEDTQKLNHRESKGVENGITKESEPHAVGRSQDKGIEIKVPSSGNR 37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Human  KEDPHNEVDGDKTSKSEENSAGIPEDNGSQRIEDTQKLNHRESKRVENRITKESETHAVGKSQDKGIEIKGPSSGNR 36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Mouse  QEGFPNGHNGDN--SSEEN--GVEEGDSTQATQDKEKLSPKDTRDAEGGIISQSEACPSGKSQ--GIETEGPNKGNK 35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Rat    QEGSPNGRGGDNTSSSEET--GIEEGDGTQTTQDNQNLSP-----TEGGIISQAEACPSGQSQNQGLETEGSSTGNK 35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Conser :*      .**:  .***   .:   . :   :  :: .      .   :   :*. . *:**  *:*   . .**: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Pig    S</a:t>
            </a:r>
            <a:r>
              <a:rPr b="1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N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ITKEAGKVSEDRESKGQHGMIVGKGSVKTQGEADIMQRPGPKSEPGNKPGPSKTH</a:t>
            </a:r>
            <a:r>
              <a:rPr b="1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S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D</a:t>
            </a:r>
            <a:r>
              <a:rPr b="1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S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N</a:t>
            </a:r>
            <a:r>
              <a:rPr b="1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S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EGYD</a:t>
            </a:r>
            <a:r>
              <a:rPr b="1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S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YEFDGKSMQG 457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Panda  NNITKEAGKVSEDKGSKRQQGMVMGKGNVKTPGETDNIQGPGPKSEPGNKVAHSKTGSDSNSDGYDSYEFDDKSMQG 45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Dog    NNITKESGKVSEDKESKRQPGMAMGKGNVKTPGETDNIQGSSQKSEPGNKVAHSKTGSESNSDGYDSYEFDDKSMQG 44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Monkey -NITKEVGKVNEDKEDKGQHGMILGKANVKTQGEVDNIEGPGQKPEPGNKVGHSHTGSDSNSDGYDSYDFDDKSMQG 448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Human  -NITKEVGKGNEGKEDKGQHGMILGKGNVKTQGEVVNIEGPGQKSEPGNKVGHSNTGSDSNSDGYDSYDFDDKSMQG 44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Mouse  SIITKESGKLSGSKDSNGHQGVELDKRNSPKQGESDKPQGTAEKSAAHSNLGHSRIGSSSNSDGHDSYEFDDESMQG 43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Rat    SSITKESGKLSGSKDSNGHHGMELDKRNSPKQGESDKPQGAAEKSDTHNNMGHSRIGSSSNSDGHDSYDFDDESMQG 43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Courier New"/>
              </a:rPr>
              <a:t>Conser   **** ** . .: .: : *: :.* .  . **    : .. *. . .: . *.  *.***:*:***:**.:****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11"/>
          <p:cNvSpPr/>
          <p:nvPr/>
        </p:nvSpPr>
        <p:spPr>
          <a:xfrm>
            <a:off x="152280" y="8748720"/>
            <a:ext cx="7467840" cy="176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80960"/>
                <a:tab algn="l" pos="961920"/>
                <a:tab algn="l" pos="1442880"/>
                <a:tab algn="l" pos="1924200"/>
                <a:tab algn="l" pos="2405160"/>
                <a:tab algn="l" pos="2886120"/>
                <a:tab algn="l" pos="3367080"/>
                <a:tab algn="l" pos="3848040"/>
                <a:tab algn="l" pos="4329000"/>
                <a:tab algn="l" pos="4809960"/>
                <a:tab algn="l" pos="5291280"/>
                <a:tab algn="l" pos="5772240"/>
                <a:tab algn="l" pos="6253200"/>
                <a:tab algn="l" pos="6734160"/>
                <a:tab algn="l" pos="7215120"/>
                <a:tab algn="l" pos="7696080"/>
                <a:tab algn="l" pos="8177040"/>
                <a:tab algn="l" pos="8658360"/>
                <a:tab algn="l" pos="9139320"/>
                <a:tab algn="l" pos="962028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6. Alignment of Dsp amino acid sequences from GenBank.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sequences in the alignment are from pig (sus scrofa, # NP_998942.1; panda (Ailuropoda melanoleuca, #EFB19868); dog (Canis familiaris, #XP_544971.2); monkey (Macaca mulatta, #XP_001098430); human (Homo sapiens, #NP_055023); mouse (Mus musculus, # AF135799.1); and rat (Rattus norvegicus, #NP_036922), which were aligned using ClustalW2. The alignment covers from the beginning of the secreted protein (Ile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1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to Gly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457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the last amino acid before the start of Dpp. Porcine Dsp ends at Arg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376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is followed by Dgp, which extends from Ser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377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ends at Gly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457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In bold are the amino acids in porcine Dsp-Dgp that are now sites of known PTMs: six N-glycosylations (Asn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37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Asn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77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Asn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136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Asn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155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Asn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161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Asn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176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, two GAG attachments (Ser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38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Ser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50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,  three O-glycosylations (Thr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00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Thr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16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and Thr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316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, one intermolecular disulfide bridge (Cys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190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. Dgp has one N-glycosylation (Asn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382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and four phosphorylations (Ser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438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Ser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440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Ser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442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and Ser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447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. The glycosylation status Asn</a:t>
            </a:r>
            <a:r>
              <a:rPr b="0" lang="en-US" sz="11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67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was not determined. Note that the strongest regions of amino acid conservation surround the two glycan attachment sites and the C-terminus of Dgp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9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1-20T15:01:26Z</dcterms:created>
  <dc:creator>James Simmer</dc:creator>
  <dc:description/>
  <dc:language>en-US</dc:language>
  <cp:lastModifiedBy>James Simmer</cp:lastModifiedBy>
  <cp:lastPrinted>2010-03-10T14:29:03Z</cp:lastPrinted>
  <dcterms:modified xsi:type="dcterms:W3CDTF">2011-01-31T16:32:54Z</dcterms:modified>
  <cp:revision>8</cp:revision>
  <dc:subject/>
  <dc:title>Slide 1</dc:title>
</cp:coreProperties>
</file>